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58"/>
    <p:restoredTop sz="94694"/>
  </p:normalViewPr>
  <p:slideViewPr>
    <p:cSldViewPr snapToGrid="0" snapToObjects="1">
      <p:cViewPr varScale="1">
        <p:scale>
          <a:sx n="72" d="100"/>
          <a:sy n="72" d="100"/>
        </p:scale>
        <p:origin x="4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6D70FE-D04C-2048-9801-23B6AFD26AFB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E83B33-315C-CA47-AB6D-3D1E8EBFF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93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I would</a:t>
            </a:r>
            <a:r>
              <a:rPr lang="en-US" baseline="0" dirty="0"/>
              <a:t> remove just use the NT </a:t>
            </a:r>
            <a:r>
              <a:rPr lang="en-US" baseline="0" dirty="0" err="1"/>
              <a:t>siRNA</a:t>
            </a:r>
            <a:r>
              <a:rPr lang="en-US" baseline="0" dirty="0"/>
              <a:t> data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0B16194-2E0C-8A41-BC97-80E122E0C6E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3902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D5DFFB-97FA-7F43-B102-5D7EEC4964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C6F0EE-6CD2-C14A-BFFE-CCD0415240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9EEC63-325C-764E-9BAC-07192CB43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49F860-C48C-4E4B-BE39-7F9C8C9E8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24959C-5A7A-7641-AAD0-AEF2D47CDC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301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06DE9C-A47C-C344-8D97-FF3241E5E2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DEE354-EE4C-0644-8868-D524C8FA8D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683B37-EBE0-5C47-8E27-D79A136E4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DCBD3C-11FE-684E-B09F-0EBE6DF11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63275B-7C20-B64D-B818-FD6325D39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157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6F6F920-B418-E94F-8C57-BE2BF44679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E3D64F-CEFD-CC45-AE6F-172C6B2EF1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3A86A7-3ABE-8B48-B503-59754C78C4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F25CE-88ED-A742-94EF-B702A8CEE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16D06F-A0BC-BE48-969A-0A875FF30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5430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6AC2D3-DF5F-9C42-AE01-A8A1C0F5A9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FF0112-8A20-CC41-A1B2-A87DEB85AA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F0FF51-6968-C34F-8AE0-23A0D3B800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8725F5-04DB-2E42-8682-27B9DDEAA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F46B48-EC16-2349-9651-9E54593F7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834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7A38BF-6026-1A4D-BB3E-867FA06D9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F28CFF-2EC9-E04B-884B-39C918DCB3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CCE706-F3F3-C740-87BC-A45F26CB9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78E9D9-74E6-9C41-A2AC-D35B0F2A4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4CBD2F-A841-D64F-A882-832567A91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891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BD65C-5A66-654E-AF6E-45918FC9EE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99CEA5-787A-7348-8841-918DF30D4F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AE10EA-10FA-A545-8766-1AF83CEF33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3831EA-65E5-7D44-93CA-51E686094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9E453A-63A6-8B45-ACA5-FD2D86D81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03164D-8B40-1B40-A6D1-94E4FA810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766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56D3BD-5AA1-DA43-9A5B-EDEC2C277E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DE3EBA-49CC-1E44-8A56-66A62E466D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C3D158-F8CD-AA4A-9081-2F199FCB31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C2DF29-98D4-E642-AABF-87B86B8D61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B236C32-6DCE-7842-A7D1-C25154EB56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324436-DCEA-1A42-9523-EFB7547E2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7751D9F-F282-B34A-B40A-68C648933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581AFED-E232-1E48-B3FE-958A1AED1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533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D136C5-EBCF-AF4E-B717-D3097384CA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80E53A5-F46A-1349-83D4-92BEFD5D5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CBB9AC-B442-D444-9908-5DC62026A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78D2F1-37FC-D640-ACD0-5A3AE911C7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563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A1565A-3178-C047-A926-B04E64533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3FA3EF3-8587-FD4C-AD8B-C13DA0DFA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DFD632-3D49-EF43-BF1A-7925B0330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67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63A4D7-C34C-DC47-B63E-BDF4C180B5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7A8B74-36CC-D749-8819-1BC994BE50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21896E-DCA4-6845-923C-ACDA14B8A4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08438B-54F5-C74B-9D4D-B47503EF6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071803-D363-E844-AF56-D592DFADBD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05E1AB-ACF2-7646-8CF9-FFE0C0AC6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637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D8548F-3318-B244-9115-C52BB0D4A6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DDCEDCF-4BF1-5645-8D37-84C92E9305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E129E3-24DA-0246-957F-D77AB30332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EFDF5F-BD1F-6642-AB13-5CCA37DE37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C40D98-5EF3-A94A-8640-7EB1C90D9D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0A631D-6DBD-F34C-9D8D-01FF54035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242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4764737-EB93-594F-AFC1-EA8B1A707B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4C0B1C-B5AF-D24B-A033-E4A79E3765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9CDBCD-4181-B348-B10A-5797FD2654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818C69-043C-224C-9F27-60A824A9B4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353F78-65F1-A447-AF4E-FF7E840554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307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74C7141B-0AA2-4417-8FF3-407CC1441F04}"/>
              </a:ext>
            </a:extLst>
          </p:cNvPr>
          <p:cNvGrpSpPr/>
          <p:nvPr/>
        </p:nvGrpSpPr>
        <p:grpSpPr>
          <a:xfrm>
            <a:off x="103568" y="1086073"/>
            <a:ext cx="6222684" cy="3820105"/>
            <a:chOff x="1649885" y="501301"/>
            <a:chExt cx="6222684" cy="3820105"/>
          </a:xfrm>
        </p:grpSpPr>
        <p:sp>
          <p:nvSpPr>
            <p:cNvPr id="20" name="TextBox 13"/>
            <p:cNvSpPr txBox="1"/>
            <p:nvPr/>
          </p:nvSpPr>
          <p:spPr bwMode="auto">
            <a:xfrm>
              <a:off x="1723580" y="501301"/>
              <a:ext cx="293670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pPr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400" b="1" kern="0" dirty="0">
                  <a:solidFill>
                    <a:srgbClr val="000000"/>
                  </a:solidFill>
                  <a:latin typeface="Calibri"/>
                  <a:cs typeface=""/>
                </a:rPr>
                <a:t>A</a:t>
              </a:r>
            </a:p>
          </p:txBody>
        </p:sp>
        <p:sp>
          <p:nvSpPr>
            <p:cNvPr id="24" name="TextBox 21"/>
            <p:cNvSpPr txBox="1">
              <a:spLocks noChangeArrowheads="1"/>
            </p:cNvSpPr>
            <p:nvPr/>
          </p:nvSpPr>
          <p:spPr bwMode="auto">
            <a:xfrm>
              <a:off x="4834140" y="501301"/>
              <a:ext cx="28725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400" b="1" dirty="0">
                  <a:solidFill>
                    <a:srgbClr val="000000"/>
                  </a:solidFill>
                </a:rPr>
                <a:t>B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735829" y="2520188"/>
              <a:ext cx="8697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Phospho p-38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937921" y="3159098"/>
              <a:ext cx="7386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900" b="1" dirty="0"/>
                <a:t>α</a:t>
              </a:r>
              <a:r>
                <a:rPr lang="en-GB" sz="900" b="1" dirty="0"/>
                <a:t>-tubulin</a:t>
              </a:r>
              <a:endParaRPr lang="en-US" sz="900" b="1" dirty="0"/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605182" y="2460952"/>
              <a:ext cx="2136738" cy="1104900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43100" y="733830"/>
              <a:ext cx="5848196" cy="1707718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1649885" y="2635604"/>
              <a:ext cx="14113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Phospho-JNK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825309" y="3159098"/>
              <a:ext cx="7386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900" b="1" dirty="0"/>
                <a:t>α</a:t>
              </a:r>
              <a:r>
                <a:rPr lang="en-GB" sz="900" b="1" dirty="0"/>
                <a:t>-tubulin</a:t>
              </a:r>
              <a:endParaRPr lang="en-US" sz="900" b="1" dirty="0"/>
            </a:p>
          </p:txBody>
        </p:sp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496918" y="2435552"/>
              <a:ext cx="2197002" cy="1130300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 rot="16200000">
              <a:off x="6356020" y="2804856"/>
              <a:ext cx="755552" cy="22775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/>
                <a:t>Control</a:t>
              </a:r>
            </a:p>
            <a:p>
              <a:pPr algn="r"/>
              <a:endParaRPr lang="en-US" sz="900" dirty="0"/>
            </a:p>
            <a:p>
              <a:pPr algn="r"/>
              <a:r>
                <a:rPr lang="en-US" sz="900" dirty="0"/>
                <a:t>IL-1β</a:t>
              </a:r>
            </a:p>
            <a:p>
              <a:pPr algn="r"/>
              <a:endParaRPr lang="en-US" sz="900" dirty="0"/>
            </a:p>
            <a:p>
              <a:pPr algn="r"/>
              <a:r>
                <a:rPr lang="en-US" sz="900" dirty="0"/>
                <a:t>P4</a:t>
              </a:r>
            </a:p>
            <a:p>
              <a:pPr algn="r"/>
              <a:endParaRPr lang="en-US" sz="900" dirty="0"/>
            </a:p>
            <a:p>
              <a:pPr algn="r"/>
              <a:r>
                <a:rPr lang="en-US" sz="900" dirty="0"/>
                <a:t>F</a:t>
              </a:r>
            </a:p>
            <a:p>
              <a:pPr algn="r"/>
              <a:endParaRPr lang="en-US" sz="900" dirty="0"/>
            </a:p>
            <a:p>
              <a:pPr algn="r"/>
              <a:r>
                <a:rPr lang="en-US" sz="900" dirty="0"/>
                <a:t>P4+IL-1β</a:t>
              </a:r>
            </a:p>
            <a:p>
              <a:pPr algn="r"/>
              <a:endParaRPr lang="en-US" sz="900" dirty="0"/>
            </a:p>
            <a:p>
              <a:pPr algn="r"/>
              <a:r>
                <a:rPr lang="en-US" sz="900" dirty="0"/>
                <a:t>F+IL-1β</a:t>
              </a:r>
            </a:p>
            <a:p>
              <a:pPr algn="r"/>
              <a:endParaRPr lang="en-US" sz="900" dirty="0"/>
            </a:p>
            <a:p>
              <a:pPr algn="r"/>
              <a:r>
                <a:rPr lang="en-US" sz="900" dirty="0"/>
                <a:t>F+P4</a:t>
              </a:r>
            </a:p>
            <a:p>
              <a:pPr algn="r"/>
              <a:endParaRPr lang="en-US" sz="900" dirty="0"/>
            </a:p>
            <a:p>
              <a:pPr algn="r"/>
              <a:r>
                <a:rPr lang="en-US" sz="900" dirty="0"/>
                <a:t>P4+F+IL-1β</a:t>
              </a:r>
            </a:p>
            <a:p>
              <a:pPr algn="r"/>
              <a:endParaRPr lang="en-US" sz="7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3289290" y="2804854"/>
              <a:ext cx="755552" cy="22775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/>
                <a:t>Control</a:t>
              </a:r>
            </a:p>
            <a:p>
              <a:pPr algn="r"/>
              <a:endParaRPr lang="en-US" sz="900" dirty="0"/>
            </a:p>
            <a:p>
              <a:pPr algn="r"/>
              <a:r>
                <a:rPr lang="en-US" sz="900" dirty="0"/>
                <a:t>IL-1β</a:t>
              </a:r>
            </a:p>
            <a:p>
              <a:pPr algn="r"/>
              <a:endParaRPr lang="en-US" sz="900" dirty="0"/>
            </a:p>
            <a:p>
              <a:pPr algn="r"/>
              <a:r>
                <a:rPr lang="en-US" sz="900" dirty="0"/>
                <a:t>P4</a:t>
              </a:r>
            </a:p>
            <a:p>
              <a:pPr algn="r"/>
              <a:endParaRPr lang="en-US" sz="900" dirty="0"/>
            </a:p>
            <a:p>
              <a:pPr algn="r"/>
              <a:r>
                <a:rPr lang="en-US" sz="900" dirty="0"/>
                <a:t>F</a:t>
              </a:r>
            </a:p>
            <a:p>
              <a:pPr algn="r"/>
              <a:endParaRPr lang="en-US" sz="900" dirty="0"/>
            </a:p>
            <a:p>
              <a:pPr algn="r"/>
              <a:r>
                <a:rPr lang="en-US" sz="900" dirty="0"/>
                <a:t>P4+IL-1β</a:t>
              </a:r>
            </a:p>
            <a:p>
              <a:pPr algn="r"/>
              <a:endParaRPr lang="en-US" sz="900" dirty="0"/>
            </a:p>
            <a:p>
              <a:pPr algn="r"/>
              <a:r>
                <a:rPr lang="en-US" sz="900" dirty="0"/>
                <a:t>F+IL-1β</a:t>
              </a:r>
            </a:p>
            <a:p>
              <a:pPr algn="r"/>
              <a:endParaRPr lang="en-US" sz="900" dirty="0"/>
            </a:p>
            <a:p>
              <a:pPr algn="r"/>
              <a:r>
                <a:rPr lang="en-US" sz="900" dirty="0"/>
                <a:t>F+P4</a:t>
              </a:r>
            </a:p>
            <a:p>
              <a:pPr algn="r"/>
              <a:endParaRPr lang="en-US" sz="900" dirty="0"/>
            </a:p>
            <a:p>
              <a:pPr algn="r"/>
              <a:r>
                <a:rPr lang="en-US" sz="900" dirty="0"/>
                <a:t>P4+F+IL-1β</a:t>
              </a:r>
            </a:p>
            <a:p>
              <a:pPr algn="r"/>
              <a:endParaRPr lang="en-US" sz="700" b="1" dirty="0"/>
            </a:p>
          </p:txBody>
        </p:sp>
      </p:grpSp>
      <p:sp>
        <p:nvSpPr>
          <p:cNvPr id="15" name="Rectangle 264">
            <a:extLst>
              <a:ext uri="{FF2B5EF4-FFF2-40B4-BE49-F238E27FC236}">
                <a16:creationId xmlns:a16="http://schemas.microsoft.com/office/drawing/2014/main" id="{12147E35-09CF-47C3-AE73-424BC194E2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568" y="129941"/>
            <a:ext cx="116859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2000" b="1">
                <a:solidFill>
                  <a:srgbClr val="000000"/>
                </a:solidFill>
                <a:latin typeface="Arial Bold" panose="020B0704020202020204" pitchFamily="34" charset="0"/>
              </a:rPr>
              <a:t>S6 Figure</a:t>
            </a:r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16854075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3</TotalTime>
  <Words>57</Words>
  <Application>Microsoft Office PowerPoint</Application>
  <PresentationFormat>Widescreen</PresentationFormat>
  <Paragraphs>3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Bold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son, Mark R</dc:creator>
  <cp:lastModifiedBy>DELL</cp:lastModifiedBy>
  <cp:revision>29</cp:revision>
  <dcterms:created xsi:type="dcterms:W3CDTF">2019-10-13T09:04:07Z</dcterms:created>
  <dcterms:modified xsi:type="dcterms:W3CDTF">2020-11-19T09:04:24Z</dcterms:modified>
</cp:coreProperties>
</file>